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 varScale="1">
        <p:scale>
          <a:sx n="74" d="100"/>
          <a:sy n="74" d="100"/>
        </p:scale>
        <p:origin x="965" y="7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6A34C5-6CD8-47C8-83B9-0A446752BC64}" type="datetimeFigureOut">
              <a:rPr kumimoji="1" lang="ja-JP" altLang="en-US" smtClean="0"/>
              <a:t>2024/12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B2646E-0612-4436-9AF9-C81710F708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4598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A36E9F4-5A7E-8CD0-3E75-001557EC532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C29C380-4C32-73F4-EC9C-BBEA56C6D9E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659CA27-53F7-4094-E37A-2A1E1F9C0B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E85F-5205-445B-918E-7C15BDC9E3C4}" type="datetimeFigureOut">
              <a:rPr kumimoji="1" lang="ja-JP" altLang="en-US" smtClean="0"/>
              <a:t>2024/12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8C232FB-3ECD-4280-FEF9-489DC5D8E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E079D75-C73E-F601-632B-DCD2E0D144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93CFA-68FE-437C-84F1-15A245603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97895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3FD87B3-8FAF-E881-2866-923D7570D7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5A3CD2A-657F-98E1-9679-D01066294B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98072B2-F936-4D5E-FC1C-61719FCE0B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E85F-5205-445B-918E-7C15BDC9E3C4}" type="datetimeFigureOut">
              <a:rPr kumimoji="1" lang="ja-JP" altLang="en-US" smtClean="0"/>
              <a:t>2024/12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ED66E19-691B-C6CC-54BA-FEC645A2AB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485D7D7-1B48-8ED9-32D1-FA1B470283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93CFA-68FE-437C-84F1-15A245603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829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4B811DA-DD1C-7305-F87A-EB18700341A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487F240-06CE-E9C9-E237-CCFCD0F636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1FF3253-DD83-7209-51D2-7A0CFCEF86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E85F-5205-445B-918E-7C15BDC9E3C4}" type="datetimeFigureOut">
              <a:rPr kumimoji="1" lang="ja-JP" altLang="en-US" smtClean="0"/>
              <a:t>2024/12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0D27234-7746-CE90-D29D-986F5B19B2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AA0AEFE-7AE4-8480-F7DF-5E2B45B9D7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93CFA-68FE-437C-84F1-15A245603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40419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F2821B9-8A21-4094-5DD6-72188F062C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93D1229-3CC0-E315-DFD2-B7AE8698D6D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A78826C-2EE7-A3B4-2CCD-07065B6288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E85F-5205-445B-918E-7C15BDC9E3C4}" type="datetimeFigureOut">
              <a:rPr kumimoji="1" lang="ja-JP" altLang="en-US" smtClean="0"/>
              <a:t>2024/12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3AD2D0D-07F5-37FA-2266-A9A6255770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DD606F3-3AD6-CF20-CE2D-FDB5747A94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93CFA-68FE-437C-84F1-15A245603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5471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E5DE6A6-E58F-9ED7-DFE6-79318109A8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66E6E6F-DE12-74FC-57B1-15931580F5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C7BAF3E-8529-5B7B-6F7F-377BD4166B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E85F-5205-445B-918E-7C15BDC9E3C4}" type="datetimeFigureOut">
              <a:rPr kumimoji="1" lang="ja-JP" altLang="en-US" smtClean="0"/>
              <a:t>2024/12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DA548CE-A3B2-D20C-910A-A8BACCC39C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C047E6C-9476-F8BC-C924-CDF393CB72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93CFA-68FE-437C-84F1-15A245603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77135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FDDCB25-B2B3-9068-143B-A35A37F2BB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6182AE1-0049-FCBB-9963-9A68F0BD321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045FB1F-88B6-19F4-0C87-48E52E642B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FB6E781-FC67-0FE0-A5C8-DF0D5531C6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E85F-5205-445B-918E-7C15BDC9E3C4}" type="datetimeFigureOut">
              <a:rPr kumimoji="1" lang="ja-JP" altLang="en-US" smtClean="0"/>
              <a:t>2024/12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2009946-F1F6-7326-3ACF-0F239F4A0B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870EAA7-D2B0-E1CD-EC8D-1516136A6C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93CFA-68FE-437C-84F1-15A245603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28633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A662FBB-253A-FDAE-1F95-23C91B6F8B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B7F8A3A-39E9-A86E-E2C4-0EC2AFE5B3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59B7F32-C5D6-79CF-F40D-02D275D5CB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ED157F7-4C41-DF5A-216A-6FD454A18DC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DF5DBF1-5EB5-0EED-30C8-6BBEBCE8A2D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B9626A4-6E4F-B28C-6AD5-B637709A2F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E85F-5205-445B-918E-7C15BDC9E3C4}" type="datetimeFigureOut">
              <a:rPr kumimoji="1" lang="ja-JP" altLang="en-US" smtClean="0"/>
              <a:t>2024/12/2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C0AAF8B-98A9-163C-8BE1-FAEBBFAB2A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8C6FDBB-872B-B0DF-7766-91F5549EC3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93CFA-68FE-437C-84F1-15A245603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0339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196DB24-F9A2-EA8F-BA24-0EA22FEF71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1ED43F4-85EC-1F61-17E7-778EAAB15B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E85F-5205-445B-918E-7C15BDC9E3C4}" type="datetimeFigureOut">
              <a:rPr kumimoji="1" lang="ja-JP" altLang="en-US" smtClean="0"/>
              <a:t>2024/12/2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3DC3CAD-1384-BB18-0B2F-E121FE6245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24DC85B-1A0C-7A4F-A67B-4371EAAD90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93CFA-68FE-437C-84F1-15A245603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5193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7EF5D3E-49D4-0582-232F-77AA8018CF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E85F-5205-445B-918E-7C15BDC9E3C4}" type="datetimeFigureOut">
              <a:rPr kumimoji="1" lang="ja-JP" altLang="en-US" smtClean="0"/>
              <a:t>2024/12/2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DE77E2C-6460-C076-A573-BDCD8D602A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0F848DE-08C0-56F9-2669-48606E6428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93CFA-68FE-437C-84F1-15A245603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92223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F96282E-0C5E-03F3-9B2F-A5F2C38703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C03F92D-6821-7896-95DA-EFF79E03D9A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0FB8340-5DF4-6A3D-F0DC-8AE3A3A9F3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8D6D7CC-F567-4204-0280-0D768443F1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E85F-5205-445B-918E-7C15BDC9E3C4}" type="datetimeFigureOut">
              <a:rPr kumimoji="1" lang="ja-JP" altLang="en-US" smtClean="0"/>
              <a:t>2024/12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18AE231-B015-73FF-FCA3-526C3287DA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F1CD202-C7F0-9605-6715-FAB4F52649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93CFA-68FE-437C-84F1-15A245603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80967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22B39BC-DA09-E693-B8E4-6928C3D427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4EA0028-81A4-E642-2F92-91C8D1716D6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AD6EA31-6272-8577-BC6D-F214D91936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373BEA8-5AA9-C371-815C-34E6CCE4C0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8E85F-5205-445B-918E-7C15BDC9E3C4}" type="datetimeFigureOut">
              <a:rPr kumimoji="1" lang="ja-JP" altLang="en-US" smtClean="0"/>
              <a:t>2024/12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6B3AD79-873B-1B36-D8F7-8F796A4CA3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90FE4B0-B072-178B-AC69-C0A5A2933B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93CFA-68FE-437C-84F1-15A245603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46843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194621E-2BC4-C85B-8708-A153149D9F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E0B7986-28D3-10C7-1D18-1AEE698464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C55E6AC-124D-05B7-6BC2-DE4AE9631AA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78E85F-5205-445B-918E-7C15BDC9E3C4}" type="datetimeFigureOut">
              <a:rPr kumimoji="1" lang="ja-JP" altLang="en-US" smtClean="0"/>
              <a:t>2024/12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EBB557F-6D3D-30F2-6AC6-B501C71CDE8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83A7843-41EC-CAE2-3509-ACC8040FCAE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893CFA-68FE-437C-84F1-15A245603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6071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FB421FA2-0018-0C48-28F5-5659F4B588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426939"/>
            <a:ext cx="7684882" cy="4322746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209A703-C2CE-9035-B68E-06E020CDB27C}"/>
              </a:ext>
            </a:extLst>
          </p:cNvPr>
          <p:cNvSpPr txBox="1"/>
          <p:nvPr/>
        </p:nvSpPr>
        <p:spPr>
          <a:xfrm>
            <a:off x="7131630" y="1374984"/>
            <a:ext cx="3093026" cy="374743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robability of POV in Regimen 7</a:t>
            </a:r>
          </a:p>
          <a:p>
            <a:pPr>
              <a:lnSpc>
                <a:spcPct val="150000"/>
              </a:lnSpc>
            </a:pP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st of Ondansetron</a:t>
            </a:r>
          </a:p>
          <a:p>
            <a:pPr>
              <a:lnSpc>
                <a:spcPct val="150000"/>
              </a:lnSpc>
            </a:pP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robability of POV in Regimen 6</a:t>
            </a:r>
          </a:p>
          <a:p>
            <a:pPr>
              <a:lnSpc>
                <a:spcPct val="150000"/>
              </a:lnSpc>
            </a:pP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st of Intravenous Fluids</a:t>
            </a:r>
          </a:p>
          <a:p>
            <a:pPr>
              <a:lnSpc>
                <a:spcPct val="150000"/>
              </a:lnSpc>
            </a:pP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st of Metoclopramide</a:t>
            </a:r>
          </a:p>
          <a:p>
            <a:pPr>
              <a:lnSpc>
                <a:spcPct val="150000"/>
              </a:lnSpc>
            </a:pP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st of Ropivacaine</a:t>
            </a:r>
          </a:p>
          <a:p>
            <a:pPr>
              <a:lnSpc>
                <a:spcPct val="150000"/>
              </a:lnSpc>
            </a:pP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st of Propofol</a:t>
            </a:r>
          </a:p>
          <a:p>
            <a:pPr>
              <a:lnSpc>
                <a:spcPct val="150000"/>
              </a:lnSpc>
            </a:pP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st of Dexamethasone</a:t>
            </a:r>
          </a:p>
          <a:p>
            <a:pPr>
              <a:lnSpc>
                <a:spcPct val="150000"/>
              </a:lnSpc>
            </a:pP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st of Fentanyl</a:t>
            </a:r>
          </a:p>
          <a:p>
            <a:pPr>
              <a:lnSpc>
                <a:spcPct val="150000"/>
              </a:lnSpc>
            </a:pP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st of Remifentanil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594A78D-91A1-1A48-2263-89531101D231}"/>
              </a:ext>
            </a:extLst>
          </p:cNvPr>
          <p:cNvSpPr txBox="1"/>
          <p:nvPr/>
        </p:nvSpPr>
        <p:spPr>
          <a:xfrm>
            <a:off x="101713" y="4760788"/>
            <a:ext cx="1454728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TP: 96.50</a:t>
            </a:r>
            <a:endParaRPr kumimoji="1" lang="ja-JP" altLang="en-US" sz="2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52D444C-3AF0-0D94-4191-B7F715509A20}"/>
              </a:ext>
            </a:extLst>
          </p:cNvPr>
          <p:cNvSpPr txBox="1"/>
          <p:nvPr/>
        </p:nvSpPr>
        <p:spPr>
          <a:xfrm>
            <a:off x="1800627" y="4453012"/>
            <a:ext cx="2896064" cy="70788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V in scenario analysis:</a:t>
            </a:r>
          </a:p>
          <a:p>
            <a:r>
              <a:rPr lang="en-US" altLang="ja-JP" sz="2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400.63</a:t>
            </a:r>
            <a:endParaRPr kumimoji="1" lang="ja-JP" altLang="en-US" sz="2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F393CAE-C574-32CC-C00F-E0A844CD9D35}"/>
              </a:ext>
            </a:extLst>
          </p:cNvPr>
          <p:cNvSpPr txBox="1"/>
          <p:nvPr/>
        </p:nvSpPr>
        <p:spPr>
          <a:xfrm>
            <a:off x="10224656" y="1374983"/>
            <a:ext cx="1865631" cy="374743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</a:t>
            </a:r>
            <a:r>
              <a:rPr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025</a:t>
            </a: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o </a:t>
            </a:r>
            <a:r>
              <a:rPr lang="en-US" altLang="ja-JP" sz="1600" dirty="0">
                <a:solidFill>
                  <a:schemeClr val="bg2">
                    <a:lumMod val="50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075</a:t>
            </a: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</a:t>
            </a:r>
          </a:p>
          <a:p>
            <a:pPr>
              <a:lnSpc>
                <a:spcPct val="150000"/>
              </a:lnSpc>
            </a:pP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</a:t>
            </a:r>
            <a:r>
              <a:rPr kumimoji="1"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.373</a:t>
            </a: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o </a:t>
            </a:r>
            <a:r>
              <a:rPr kumimoji="1" lang="en-US" altLang="ja-JP" sz="1600" dirty="0">
                <a:solidFill>
                  <a:schemeClr val="bg2">
                    <a:lumMod val="50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1.379</a:t>
            </a: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</a:t>
            </a:r>
          </a:p>
          <a:p>
            <a:pPr>
              <a:lnSpc>
                <a:spcPct val="150000"/>
              </a:lnSpc>
            </a:pP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</a:t>
            </a:r>
            <a:r>
              <a:rPr lang="en-US" altLang="ja-JP" sz="1600" dirty="0">
                <a:solidFill>
                  <a:schemeClr val="bg2">
                    <a:lumMod val="50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111</a:t>
            </a: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o </a:t>
            </a:r>
            <a:r>
              <a:rPr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080</a:t>
            </a: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</a:t>
            </a:r>
            <a:endParaRPr kumimoji="1" lang="en-US" altLang="ja-JP" sz="16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</a:t>
            </a:r>
            <a:r>
              <a:rPr lang="en-US" altLang="ja-JP" sz="1600" dirty="0">
                <a:solidFill>
                  <a:schemeClr val="bg2">
                    <a:lumMod val="50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.366</a:t>
            </a: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o </a:t>
            </a:r>
            <a:r>
              <a:rPr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.378</a:t>
            </a: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</a:t>
            </a:r>
          </a:p>
          <a:p>
            <a:pPr>
              <a:lnSpc>
                <a:spcPct val="150000"/>
              </a:lnSpc>
            </a:pP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</a:t>
            </a:r>
            <a:r>
              <a:rPr lang="en-US" altLang="ja-JP" sz="1600" dirty="0">
                <a:solidFill>
                  <a:schemeClr val="bg2">
                    <a:lumMod val="50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377</a:t>
            </a: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o </a:t>
            </a:r>
            <a:r>
              <a:rPr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371</a:t>
            </a: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</a:t>
            </a:r>
            <a:endParaRPr kumimoji="1" lang="en-US" altLang="ja-JP" sz="16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</a:t>
            </a:r>
            <a:r>
              <a:rPr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.866</a:t>
            </a: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o </a:t>
            </a:r>
            <a:r>
              <a:rPr lang="en-US" altLang="ja-JP" sz="1600" dirty="0">
                <a:solidFill>
                  <a:schemeClr val="bg2">
                    <a:lumMod val="50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3.380</a:t>
            </a: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</a:t>
            </a:r>
          </a:p>
          <a:p>
            <a:pPr>
              <a:lnSpc>
                <a:spcPct val="150000"/>
              </a:lnSpc>
            </a:pP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</a:t>
            </a:r>
            <a:r>
              <a:rPr lang="en-US" altLang="ja-JP" sz="1600" dirty="0">
                <a:solidFill>
                  <a:schemeClr val="bg2">
                    <a:lumMod val="50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0244</a:t>
            </a: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o </a:t>
            </a:r>
            <a:r>
              <a:rPr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0193</a:t>
            </a: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</a:t>
            </a:r>
            <a:endParaRPr kumimoji="1" lang="en-US" altLang="ja-JP" sz="16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</a:t>
            </a:r>
            <a:r>
              <a:rPr lang="en-US" altLang="ja-JP" sz="1600" dirty="0">
                <a:solidFill>
                  <a:schemeClr val="bg2">
                    <a:lumMod val="50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.404</a:t>
            </a: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o </a:t>
            </a:r>
            <a:r>
              <a:rPr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.281</a:t>
            </a: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</a:t>
            </a:r>
          </a:p>
          <a:p>
            <a:pPr>
              <a:lnSpc>
                <a:spcPct val="150000"/>
              </a:lnSpc>
            </a:pP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</a:t>
            </a:r>
            <a:r>
              <a:rPr lang="en-US" altLang="ja-JP" sz="1600" dirty="0">
                <a:solidFill>
                  <a:schemeClr val="bg2">
                    <a:lumMod val="50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0164</a:t>
            </a: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o </a:t>
            </a:r>
            <a:r>
              <a:rPr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0157</a:t>
            </a: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</a:t>
            </a:r>
            <a:endParaRPr kumimoji="1" lang="en-US" altLang="ja-JP" sz="16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pPr>
              <a:lnSpc>
                <a:spcPct val="150000"/>
              </a:lnSpc>
            </a:pP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</a:t>
            </a:r>
            <a:r>
              <a:rPr kumimoji="1"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0030</a:t>
            </a: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o </a:t>
            </a:r>
            <a:r>
              <a:rPr kumimoji="1" lang="en-US" altLang="ja-JP" sz="1600" dirty="0">
                <a:solidFill>
                  <a:schemeClr val="bg2">
                    <a:lumMod val="50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0057</a:t>
            </a: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50990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3</TotalTime>
  <Words>96</Words>
  <Application>Microsoft Office PowerPoint</Application>
  <PresentationFormat>ワイド画面</PresentationFormat>
  <Paragraphs>2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oichiro Obara</dc:creator>
  <cp:lastModifiedBy>Soichiro Obara</cp:lastModifiedBy>
  <cp:revision>16</cp:revision>
  <dcterms:created xsi:type="dcterms:W3CDTF">2024-12-18T00:08:32Z</dcterms:created>
  <dcterms:modified xsi:type="dcterms:W3CDTF">2024-12-28T17:03:12Z</dcterms:modified>
</cp:coreProperties>
</file>